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548"/>
  </p:normalViewPr>
  <p:slideViewPr>
    <p:cSldViewPr snapToGrid="0">
      <p:cViewPr varScale="1">
        <p:scale>
          <a:sx n="107" d="100"/>
          <a:sy n="107" d="100"/>
        </p:scale>
        <p:origin x="71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BB1612-2097-49E6-839E-CD9F42BCAC48}" type="datetimeFigureOut">
              <a:rPr lang="en-US" smtClean="0"/>
              <a:t>6/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3F758A-1D2D-458B-9A1F-FA6DC6A4C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28518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C3F758A-1D2D-458B-9A1F-FA6DC6A4C0A0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6611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4B2F74-34AE-6824-4990-256C5D8DDC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17C3AA1-6EB2-AEA6-9376-4C3CAF3895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34D384-A34D-21F6-2612-D35FBD86D6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F4178-5C2A-44CA-B0AA-E3988FC10485}" type="datetimeFigureOut">
              <a:rPr lang="en-US" smtClean="0"/>
              <a:t>6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B34155-1E2E-7C25-C8E9-81384265D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98090A-5F64-219D-A613-DED3E3EA1B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74B64-5C7B-4160-ABAB-9482C2CF9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527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DBA2BF-2BBF-5555-D4A2-45324B24B7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030FA0-B1A3-3FF4-713D-511A55DD6B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03DF7A-0073-C254-3CFD-B6D995362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F4178-5C2A-44CA-B0AA-E3988FC10485}" type="datetimeFigureOut">
              <a:rPr lang="en-US" smtClean="0"/>
              <a:t>6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83C23F-458C-3C71-DCDA-445A73984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35EE82-9F78-68D7-D3F5-A526FDA96A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74B64-5C7B-4160-ABAB-9482C2CF9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9178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922D143-1B15-3C89-3AD4-20C396D13E1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133E4D-4B61-0224-C5AB-FEC6A10122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40FEE8-A8E5-6080-A20F-B20FA385FE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F4178-5C2A-44CA-B0AA-E3988FC10485}" type="datetimeFigureOut">
              <a:rPr lang="en-US" smtClean="0"/>
              <a:t>6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8E3D43-505A-DF36-5FD7-CAD9D0097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E4134C-BF78-E351-8A19-5013F9B04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74B64-5C7B-4160-ABAB-9482C2CF9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279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60E100-F62A-77F8-6EA0-4A785797AE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9AC27F-25B8-364D-6607-00135C2434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12D845-2F25-2B42-0341-76CC493A92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F4178-5C2A-44CA-B0AA-E3988FC10485}" type="datetimeFigureOut">
              <a:rPr lang="en-US" smtClean="0"/>
              <a:t>6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40B259-24AF-C938-4B11-94D6696267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10B0EA-37D5-9A17-0B15-7F8AEFCB7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74B64-5C7B-4160-ABAB-9482C2CF9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9859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C5E657-D04A-AD12-FAD5-9C84466E20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93EC30-8646-DDA9-F52F-ABCBDA92FF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F47C7E-6223-1AB0-C042-2B93DC9B8B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F4178-5C2A-44CA-B0AA-E3988FC10485}" type="datetimeFigureOut">
              <a:rPr lang="en-US" smtClean="0"/>
              <a:t>6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685BC0-20C8-0B54-E2EC-C5555AF114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E88CC4-B49D-EC8D-051A-3CCC2966C4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74B64-5C7B-4160-ABAB-9482C2CF9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030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69713B-89AB-95A4-38CB-04871F96D1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4888F8-981A-9B7F-0454-29020A6D21A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1351484-ADB4-FCF3-512E-F21BBD99D8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F78327-F86F-1EE9-8292-23178139FD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F4178-5C2A-44CA-B0AA-E3988FC10485}" type="datetimeFigureOut">
              <a:rPr lang="en-US" smtClean="0"/>
              <a:t>6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F6873A-D494-6BAE-F0D1-CD2333AF6D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3FB9CF-A709-1CE8-4FE6-E05E3259D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74B64-5C7B-4160-ABAB-9482C2CF9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146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74EDED-0FA2-3C55-FD5D-F74BB9513C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52F0BD-D675-34E8-F682-AA9FCE4207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E39A162-F495-8375-0BC0-57BB21C63D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A207AF-6221-1EC7-B2D6-B05DB41B02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0B388B2-FDCA-EE48-6221-2CFFB975F2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C980886-7349-AD6B-DA98-DF50530763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F4178-5C2A-44CA-B0AA-E3988FC10485}" type="datetimeFigureOut">
              <a:rPr lang="en-US" smtClean="0"/>
              <a:t>6/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4B43739-928F-1EF5-4025-F404F2582B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91EC11-F13B-860E-E3CD-E4169226E3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74B64-5C7B-4160-ABAB-9482C2CF9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67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AB1060-0854-2F3E-13B0-AEE52D04C9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0AF11A-B7AA-1F02-DEA0-2C5C650F81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F4178-5C2A-44CA-B0AA-E3988FC10485}" type="datetimeFigureOut">
              <a:rPr lang="en-US" smtClean="0"/>
              <a:t>6/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D6FEE85-4008-5E9F-1723-92A71DFF4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684895E-CB35-0F05-E24F-79F702E9D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74B64-5C7B-4160-ABAB-9482C2CF9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626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E771700-74D5-E1EE-1A50-130390BBAA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F4178-5C2A-44CA-B0AA-E3988FC10485}" type="datetimeFigureOut">
              <a:rPr lang="en-US" smtClean="0"/>
              <a:t>6/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3E4365D-9E36-59BC-383E-AAFBCEB20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F04A6F-04E0-29FA-03FD-A7A58D208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74B64-5C7B-4160-ABAB-9482C2CF9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46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D9258B-7C08-DED9-86EF-B55C548E86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FA16CD-63A8-EEBC-609E-589BD64B9C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3AC6E0-5328-2A17-D062-3D6139853E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BFF61B-A20C-BC99-8BE4-3578B5EC4B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F4178-5C2A-44CA-B0AA-E3988FC10485}" type="datetimeFigureOut">
              <a:rPr lang="en-US" smtClean="0"/>
              <a:t>6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7E9003-A562-47FF-5E87-0AD0932353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025188-5BBF-C85F-6FA4-55D8DDD850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74B64-5C7B-4160-ABAB-9482C2CF9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135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9BF3D1-5917-A1A8-8ACB-2FFE52B6EA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B4D6157-DCFF-B435-3922-30426BA878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71BCC2-AB9E-1326-3D67-A0B3DDBBD8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F66D57-FD49-0440-0A31-ADD89986BF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F4178-5C2A-44CA-B0AA-E3988FC10485}" type="datetimeFigureOut">
              <a:rPr lang="en-US" smtClean="0"/>
              <a:t>6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63E620-B748-3E88-4072-8CF755A97D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17C30E-17BA-A623-F226-4AF89E7CC1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074B64-5C7B-4160-ABAB-9482C2CF9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0936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0F78BCE-9484-4F21-53AE-D95EE6D581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A6609E-358B-6EA9-76FC-403AF537D6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6066FA-78F1-4CC1-509A-E5223EC377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6F4178-5C2A-44CA-B0AA-E3988FC10485}" type="datetimeFigureOut">
              <a:rPr lang="en-US" smtClean="0"/>
              <a:t>6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FDA6C5-11EB-BC3F-AC75-D0172BC406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77DDCC-2BC1-AC2A-7A4D-C5C725FE11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074B64-5C7B-4160-ABAB-9482C2CF9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6501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B593825-8E26-6241-4BFF-9850753BB4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74581" y="143802"/>
            <a:ext cx="4896533" cy="582058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25232B5-9491-6C25-183D-2E5E6BE6CB50}"/>
              </a:ext>
            </a:extLst>
          </p:cNvPr>
          <p:cNvSpPr txBox="1"/>
          <p:nvPr/>
        </p:nvSpPr>
        <p:spPr>
          <a:xfrm>
            <a:off x="1584198" y="6027003"/>
            <a:ext cx="9370314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i="0" dirty="0">
                <a:solidFill>
                  <a:srgbClr val="000000"/>
                </a:solidFill>
                <a:effectLst/>
                <a:latin typeface="Arial-BoldMT"/>
              </a:rPr>
              <a:t>Supplementary Figure S1. </a:t>
            </a:r>
            <a:r>
              <a:rPr lang="en-US" sz="1400" b="0" i="0" dirty="0">
                <a:solidFill>
                  <a:srgbClr val="000000"/>
                </a:solidFill>
                <a:effectLst/>
                <a:latin typeface="ArialMT"/>
              </a:rPr>
              <a:t>Venn diagram to summarize miRNAs that are differentially expressed in</a:t>
            </a:r>
            <a:br>
              <a:rPr lang="en-US" sz="1400" b="0" i="0" dirty="0">
                <a:solidFill>
                  <a:srgbClr val="000000"/>
                </a:solidFill>
                <a:effectLst/>
                <a:latin typeface="ArialMT"/>
              </a:rPr>
            </a:br>
            <a:r>
              <a:rPr lang="en-US" sz="1400" b="0" i="0" dirty="0">
                <a:solidFill>
                  <a:srgbClr val="000000"/>
                </a:solidFill>
                <a:effectLst/>
                <a:latin typeface="ArialMT"/>
              </a:rPr>
              <a:t>three individual saliva fractions.</a:t>
            </a:r>
            <a:r>
              <a:rPr lang="en-US" sz="1400" dirty="0"/>
              <a:t> </a:t>
            </a:r>
            <a:r>
              <a:rPr lang="en-US" sz="1400" dirty="0">
                <a:solidFill>
                  <a:srgbClr val="000000"/>
                </a:solidFill>
                <a:latin typeface="ArialMT"/>
              </a:rPr>
              <a:t>CFS, cell-free saliva; EXO, exosome; EV-D, EV-depleted saliva. </a:t>
            </a:r>
            <a:br>
              <a:rPr lang="en-US" sz="1400" dirty="0"/>
            </a:br>
            <a:endParaRPr lang="en-US" sz="14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8279409-77C1-6819-1282-7361E5F6ACA1}"/>
              </a:ext>
            </a:extLst>
          </p:cNvPr>
          <p:cNvSpPr txBox="1"/>
          <p:nvPr/>
        </p:nvSpPr>
        <p:spPr>
          <a:xfrm>
            <a:off x="173355" y="81188"/>
            <a:ext cx="6096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0" dirty="0">
                <a:solidFill>
                  <a:srgbClr val="000000"/>
                </a:solidFill>
                <a:effectLst/>
                <a:latin typeface="Arial-BoldMT"/>
              </a:rPr>
              <a:t>Supplementary Figure S1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2638071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21E15F9-A382-7AF2-F9D3-0330DD0B03C7}"/>
              </a:ext>
            </a:extLst>
          </p:cNvPr>
          <p:cNvSpPr txBox="1"/>
          <p:nvPr/>
        </p:nvSpPr>
        <p:spPr>
          <a:xfrm>
            <a:off x="173355" y="81188"/>
            <a:ext cx="6096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0" dirty="0">
                <a:solidFill>
                  <a:srgbClr val="000000"/>
                </a:solidFill>
                <a:effectLst/>
                <a:latin typeface="Arial-BoldMT"/>
              </a:rPr>
              <a:t>Supplementary Figure S2</a:t>
            </a:r>
            <a:endParaRPr lang="en-US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9E18243-366A-EDC3-6A95-7CCF5ADC6BF2}"/>
              </a:ext>
            </a:extLst>
          </p:cNvPr>
          <p:cNvSpPr txBox="1"/>
          <p:nvPr/>
        </p:nvSpPr>
        <p:spPr>
          <a:xfrm>
            <a:off x="746695" y="5363799"/>
            <a:ext cx="10811444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i="0" dirty="0">
                <a:solidFill>
                  <a:srgbClr val="000000"/>
                </a:solidFill>
                <a:effectLst/>
                <a:latin typeface="Arial-BoldMT"/>
              </a:rPr>
              <a:t>Supplementary Figure S2.  </a:t>
            </a:r>
            <a:r>
              <a:rPr lang="en-US" sz="1400" i="0" dirty="0">
                <a:solidFill>
                  <a:srgbClr val="000000"/>
                </a:solidFill>
                <a:effectLst/>
                <a:latin typeface="Arial-BoldMT"/>
              </a:rPr>
              <a:t>Nanoparticle tracking analysis (NTA) quantification for four saliva fractions. A representative result from each saliva fraction is shown here. (</a:t>
            </a:r>
            <a:r>
              <a:rPr lang="en-US" sz="1400" b="1" i="0" dirty="0">
                <a:solidFill>
                  <a:srgbClr val="000000"/>
                </a:solidFill>
                <a:effectLst/>
                <a:latin typeface="Arial-BoldMT"/>
              </a:rPr>
              <a:t>A</a:t>
            </a:r>
            <a:r>
              <a:rPr lang="en-US" sz="1400" i="0" dirty="0">
                <a:solidFill>
                  <a:srgbClr val="000000"/>
                </a:solidFill>
                <a:effectLst/>
                <a:latin typeface="Arial-BoldMT"/>
              </a:rPr>
              <a:t>) The size of particles in CFS is mainly in the range of 0-200 nm. (</a:t>
            </a:r>
            <a:r>
              <a:rPr lang="en-US" sz="1400" b="1" i="0" dirty="0">
                <a:solidFill>
                  <a:srgbClr val="000000"/>
                </a:solidFill>
                <a:effectLst/>
                <a:latin typeface="Arial-BoldMT"/>
              </a:rPr>
              <a:t>B-C</a:t>
            </a:r>
            <a:r>
              <a:rPr lang="en-US" sz="1400" i="0" dirty="0">
                <a:solidFill>
                  <a:srgbClr val="000000"/>
                </a:solidFill>
                <a:effectLst/>
                <a:latin typeface="Arial-BoldMT"/>
              </a:rPr>
              <a:t>) The NTA results showed that the diameters of EXO and MV met the standard sizes 30-150 nm and 0.1-1.0 µm, respectively</a:t>
            </a:r>
            <a:r>
              <a:rPr lang="en-US" sz="1400" dirty="0">
                <a:solidFill>
                  <a:srgbClr val="000000"/>
                </a:solidFill>
                <a:latin typeface="Arial-BoldMT"/>
              </a:rPr>
              <a:t>. </a:t>
            </a:r>
            <a:r>
              <a:rPr lang="en-US" sz="1400" i="0" dirty="0">
                <a:solidFill>
                  <a:srgbClr val="000000"/>
                </a:solidFill>
                <a:effectLst/>
                <a:latin typeface="Arial-BoldMT"/>
              </a:rPr>
              <a:t>(</a:t>
            </a:r>
            <a:r>
              <a:rPr lang="en-US" sz="1400" b="1" i="0" dirty="0">
                <a:solidFill>
                  <a:srgbClr val="000000"/>
                </a:solidFill>
                <a:effectLst/>
                <a:latin typeface="Arial-BoldMT"/>
              </a:rPr>
              <a:t>D</a:t>
            </a:r>
            <a:r>
              <a:rPr lang="en-US" sz="1400" i="0" dirty="0">
                <a:solidFill>
                  <a:srgbClr val="000000"/>
                </a:solidFill>
                <a:effectLst/>
                <a:latin typeface="Arial-BoldMT"/>
              </a:rPr>
              <a:t>). The size of particles in EV-D is mainly in the range of 0-300 nm. CFS, cell-free saliva; EXO, exosome; MV, </a:t>
            </a:r>
            <a:r>
              <a:rPr lang="en-US" sz="1400" i="0" dirty="0" err="1">
                <a:solidFill>
                  <a:srgbClr val="000000"/>
                </a:solidFill>
                <a:effectLst/>
                <a:latin typeface="Arial-BoldMT"/>
              </a:rPr>
              <a:t>microvesicle</a:t>
            </a:r>
            <a:r>
              <a:rPr lang="en-US" sz="1400" i="0" dirty="0">
                <a:solidFill>
                  <a:srgbClr val="000000"/>
                </a:solidFill>
                <a:effectLst/>
                <a:latin typeface="Arial-BoldMT"/>
              </a:rPr>
              <a:t>; EV-D, EV-depleted saliva. </a:t>
            </a:r>
            <a:endParaRPr lang="en-US" sz="1400" dirty="0"/>
          </a:p>
        </p:txBody>
      </p:sp>
      <p:pic>
        <p:nvPicPr>
          <p:cNvPr id="7" name="Picture 6" descr="A picture containing text, diagram, plot, line&#10;&#10;Description automatically generated">
            <a:extLst>
              <a:ext uri="{FF2B5EF4-FFF2-40B4-BE49-F238E27FC236}">
                <a16:creationId xmlns:a16="http://schemas.microsoft.com/office/drawing/2014/main" id="{A6965555-67EF-8FF4-E746-3D88C1C2E5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6695" y="1867637"/>
            <a:ext cx="10811444" cy="3496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59008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F898DB6-0777-4FBE-2369-7F52F3567E68}"/>
              </a:ext>
            </a:extLst>
          </p:cNvPr>
          <p:cNvSpPr txBox="1"/>
          <p:nvPr/>
        </p:nvSpPr>
        <p:spPr>
          <a:xfrm>
            <a:off x="173355" y="81188"/>
            <a:ext cx="6096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0" dirty="0">
                <a:solidFill>
                  <a:srgbClr val="000000"/>
                </a:solidFill>
                <a:effectLst/>
                <a:latin typeface="Arial-BoldMT"/>
              </a:rPr>
              <a:t>Supplementary Figure S3</a:t>
            </a:r>
            <a:endParaRPr lang="en-US" sz="1200" dirty="0"/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855FE726-BD2D-3BE0-DB61-B682328F59D5}"/>
              </a:ext>
            </a:extLst>
          </p:cNvPr>
          <p:cNvGrpSpPr/>
          <p:nvPr/>
        </p:nvGrpSpPr>
        <p:grpSpPr>
          <a:xfrm>
            <a:off x="367553" y="219687"/>
            <a:ext cx="11940547" cy="5670103"/>
            <a:chOff x="358588" y="636494"/>
            <a:chExt cx="11940547" cy="5670103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BFCFDB30-2688-6C6F-D133-50D45187E864}"/>
                </a:ext>
              </a:extLst>
            </p:cNvPr>
            <p:cNvGrpSpPr/>
            <p:nvPr/>
          </p:nvGrpSpPr>
          <p:grpSpPr>
            <a:xfrm>
              <a:off x="433331" y="968611"/>
              <a:ext cx="6057116" cy="2275691"/>
              <a:chOff x="2405566" y="3898670"/>
              <a:chExt cx="6057116" cy="2275691"/>
            </a:xfrm>
          </p:grpSpPr>
          <p:pic>
            <p:nvPicPr>
              <p:cNvPr id="8" name="Picture 7" descr="A screenshot of a computer&#10;&#10;Description automatically generated">
                <a:extLst>
                  <a:ext uri="{FF2B5EF4-FFF2-40B4-BE49-F238E27FC236}">
                    <a16:creationId xmlns:a16="http://schemas.microsoft.com/office/drawing/2014/main" id="{FB31B026-C965-7AEA-77A4-E273EF97B1B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89" t="25652" r="14418" b="19744"/>
              <a:stretch/>
            </p:blipFill>
            <p:spPr>
              <a:xfrm>
                <a:off x="2405566" y="3898670"/>
                <a:ext cx="5160646" cy="2275691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C0267429-A494-76B5-6EA2-490F7771132E}"/>
                  </a:ext>
                </a:extLst>
              </p:cNvPr>
              <p:cNvSpPr txBox="1"/>
              <p:nvPr/>
            </p:nvSpPr>
            <p:spPr>
              <a:xfrm>
                <a:off x="2843613" y="4112507"/>
                <a:ext cx="177338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CFS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C27667B9-265F-47EA-945A-B8DB1C4ACB48}"/>
                  </a:ext>
                </a:extLst>
              </p:cNvPr>
              <p:cNvSpPr txBox="1"/>
              <p:nvPr/>
            </p:nvSpPr>
            <p:spPr>
              <a:xfrm>
                <a:off x="6096000" y="4158674"/>
                <a:ext cx="2366682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RIN 4.0</a:t>
                </a:r>
              </a:p>
              <a:p>
                <a:r>
                  <a:rPr lang="en-US" sz="1400" dirty="0"/>
                  <a:t>39.6 ng/</a:t>
                </a:r>
                <a:r>
                  <a:rPr lang="en-US" sz="1400" dirty="0">
                    <a:effectLst/>
                    <a:ea typeface="DengXian" panose="02010600030101010101" pitchFamily="2" charset="-122"/>
                  </a:rPr>
                  <a:t>µ</a:t>
                </a:r>
                <a:r>
                  <a:rPr lang="en-US" sz="1400" dirty="0"/>
                  <a:t>l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A25F0057-EFE5-381B-68E9-B49F832B49AC}"/>
                </a:ext>
              </a:extLst>
            </p:cNvPr>
            <p:cNvGrpSpPr/>
            <p:nvPr/>
          </p:nvGrpSpPr>
          <p:grpSpPr>
            <a:xfrm>
              <a:off x="6096000" y="904691"/>
              <a:ext cx="6203135" cy="2276856"/>
              <a:chOff x="6096000" y="904691"/>
              <a:chExt cx="6203135" cy="2276856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E3D5B358-D02F-F56C-1F4B-8A96B801F14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096000" y="904691"/>
                <a:ext cx="5572145" cy="2276856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261C4956-2954-2C5B-953C-6274FBE1E178}"/>
                  </a:ext>
                </a:extLst>
              </p:cNvPr>
              <p:cNvSpPr txBox="1"/>
              <p:nvPr/>
            </p:nvSpPr>
            <p:spPr>
              <a:xfrm>
                <a:off x="6726990" y="1092797"/>
                <a:ext cx="47716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EXO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9947C683-1B6C-32FB-01FE-37C84E83D29A}"/>
                  </a:ext>
                </a:extLst>
              </p:cNvPr>
              <p:cNvSpPr txBox="1"/>
              <p:nvPr/>
            </p:nvSpPr>
            <p:spPr>
              <a:xfrm>
                <a:off x="9932453" y="1156002"/>
                <a:ext cx="2366682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RIN 2.6</a:t>
                </a:r>
              </a:p>
              <a:p>
                <a:r>
                  <a:rPr lang="en-US" sz="1400" dirty="0"/>
                  <a:t>13.5 ng/</a:t>
                </a:r>
                <a:r>
                  <a:rPr lang="en-US" sz="1400" dirty="0">
                    <a:effectLst/>
                    <a:ea typeface="DengXian" panose="02010600030101010101" pitchFamily="2" charset="-122"/>
                  </a:rPr>
                  <a:t>µ</a:t>
                </a:r>
                <a:r>
                  <a:rPr lang="en-US" sz="1400" dirty="0"/>
                  <a:t>l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FADAB1B8-5AD9-B4E6-F408-95EB25EE27DB}"/>
                </a:ext>
              </a:extLst>
            </p:cNvPr>
            <p:cNvGrpSpPr/>
            <p:nvPr/>
          </p:nvGrpSpPr>
          <p:grpSpPr>
            <a:xfrm>
              <a:off x="358588" y="4022397"/>
              <a:ext cx="6131859" cy="2284200"/>
              <a:chOff x="358588" y="4022397"/>
              <a:chExt cx="6131859" cy="2284200"/>
            </a:xfrm>
          </p:grpSpPr>
          <p:pic>
            <p:nvPicPr>
              <p:cNvPr id="16" name="Picture 15" descr="A screenshot of a computer&#10;&#10;Description automatically generated">
                <a:extLst>
                  <a:ext uri="{FF2B5EF4-FFF2-40B4-BE49-F238E27FC236}">
                    <a16:creationId xmlns:a16="http://schemas.microsoft.com/office/drawing/2014/main" id="{E790930B-7210-9FC3-E349-AC246FA51DB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959" t="19940" r="15154" b="25609"/>
              <a:stretch/>
            </p:blipFill>
            <p:spPr>
              <a:xfrm>
                <a:off x="358588" y="4022397"/>
                <a:ext cx="5160646" cy="2284200"/>
              </a:xfrm>
              <a:prstGeom prst="rect">
                <a:avLst/>
              </a:prstGeom>
            </p:spPr>
          </p:pic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640F3FF4-860C-9E8C-DA61-1110F0FA12D5}"/>
                  </a:ext>
                </a:extLst>
              </p:cNvPr>
              <p:cNvSpPr txBox="1"/>
              <p:nvPr/>
            </p:nvSpPr>
            <p:spPr>
              <a:xfrm>
                <a:off x="871378" y="4257342"/>
                <a:ext cx="177338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MV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4980AD5C-1B7E-F9D4-6FC2-142178BE29E3}"/>
                  </a:ext>
                </a:extLst>
              </p:cNvPr>
              <p:cNvSpPr txBox="1"/>
              <p:nvPr/>
            </p:nvSpPr>
            <p:spPr>
              <a:xfrm>
                <a:off x="4123765" y="4303509"/>
                <a:ext cx="2366682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RIN 4.7</a:t>
                </a:r>
              </a:p>
              <a:p>
                <a:r>
                  <a:rPr lang="en-US" sz="1400" dirty="0"/>
                  <a:t>16.2 ng/</a:t>
                </a:r>
                <a:r>
                  <a:rPr lang="en-US" sz="1400" dirty="0">
                    <a:effectLst/>
                    <a:ea typeface="DengXian" panose="02010600030101010101" pitchFamily="2" charset="-122"/>
                  </a:rPr>
                  <a:t>µ</a:t>
                </a:r>
                <a:r>
                  <a:rPr lang="en-US" sz="1400" dirty="0"/>
                  <a:t>l</a:t>
                </a:r>
              </a:p>
            </p:txBody>
          </p:sp>
        </p:grpSp>
        <p:pic>
          <p:nvPicPr>
            <p:cNvPr id="21" name="Picture 20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A253A4EA-825D-67F1-AED9-A1D36BC2D90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33" t="24562" r="13835" b="22859"/>
            <a:stretch/>
          </p:blipFill>
          <p:spPr>
            <a:xfrm>
              <a:off x="6096000" y="4004467"/>
              <a:ext cx="5451661" cy="2284200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901F049-7175-6393-E9F5-7F215A99DA60}"/>
                </a:ext>
              </a:extLst>
            </p:cNvPr>
            <p:cNvSpPr txBox="1"/>
            <p:nvPr/>
          </p:nvSpPr>
          <p:spPr>
            <a:xfrm>
              <a:off x="6687667" y="4231790"/>
              <a:ext cx="5916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EV-D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801D752-30A0-1CB1-A100-36FD2CA545C5}"/>
                </a:ext>
              </a:extLst>
            </p:cNvPr>
            <p:cNvSpPr txBox="1"/>
            <p:nvPr/>
          </p:nvSpPr>
          <p:spPr>
            <a:xfrm>
              <a:off x="9932453" y="4241656"/>
              <a:ext cx="236668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RIN 1.6</a:t>
              </a:r>
            </a:p>
            <a:p>
              <a:r>
                <a:rPr lang="en-US" sz="1400" dirty="0"/>
                <a:t>29.7 ng/</a:t>
              </a:r>
              <a:r>
                <a:rPr lang="en-US" sz="1400" dirty="0">
                  <a:effectLst/>
                  <a:ea typeface="DengXian" panose="02010600030101010101" pitchFamily="2" charset="-122"/>
                </a:rPr>
                <a:t>µ</a:t>
              </a:r>
              <a:r>
                <a:rPr lang="en-US" sz="1400" dirty="0"/>
                <a:t>l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9157FDC-1CB2-4806-845D-A81FDC3F5E80}"/>
                </a:ext>
              </a:extLst>
            </p:cNvPr>
            <p:cNvSpPr txBox="1"/>
            <p:nvPr/>
          </p:nvSpPr>
          <p:spPr>
            <a:xfrm>
              <a:off x="433331" y="636494"/>
              <a:ext cx="3197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F290F07-FB8A-6958-8508-83F5793FBD8C}"/>
                </a:ext>
              </a:extLst>
            </p:cNvPr>
            <p:cNvSpPr txBox="1"/>
            <p:nvPr/>
          </p:nvSpPr>
          <p:spPr>
            <a:xfrm>
              <a:off x="6269355" y="636494"/>
              <a:ext cx="3197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AE5E2A4C-277F-5EAB-5E8E-693CEAD78A34}"/>
                </a:ext>
              </a:extLst>
            </p:cNvPr>
            <p:cNvSpPr txBox="1"/>
            <p:nvPr/>
          </p:nvSpPr>
          <p:spPr>
            <a:xfrm>
              <a:off x="422851" y="3819801"/>
              <a:ext cx="3197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4042A18-F85C-1D8C-F8DB-B5475594F669}"/>
                </a:ext>
              </a:extLst>
            </p:cNvPr>
            <p:cNvSpPr txBox="1"/>
            <p:nvPr/>
          </p:nvSpPr>
          <p:spPr>
            <a:xfrm>
              <a:off x="6258875" y="3819801"/>
              <a:ext cx="3197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D</a:t>
              </a: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E758CAB7-3B2A-E73F-E959-3BD799D652AF}"/>
              </a:ext>
            </a:extLst>
          </p:cNvPr>
          <p:cNvSpPr txBox="1"/>
          <p:nvPr/>
        </p:nvSpPr>
        <p:spPr>
          <a:xfrm>
            <a:off x="115056" y="5903893"/>
            <a:ext cx="11961888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i="0" dirty="0">
                <a:solidFill>
                  <a:srgbClr val="000000"/>
                </a:solidFill>
                <a:effectLst/>
                <a:latin typeface="Arial-BoldMT"/>
              </a:rPr>
              <a:t>Supplementary Figure S3.  </a:t>
            </a:r>
            <a:r>
              <a:rPr lang="en-US" sz="1400" i="0" dirty="0">
                <a:solidFill>
                  <a:srgbClr val="000000"/>
                </a:solidFill>
                <a:effectLst/>
                <a:latin typeface="Arial-BoldMT"/>
              </a:rPr>
              <a:t>Tapestation electropherograms of RNAs isolated from four saliva fractions. A representative result from each saliva fraction is shown here. </a:t>
            </a:r>
            <a:r>
              <a:rPr lang="en-US" sz="1400" dirty="0">
                <a:solidFill>
                  <a:srgbClr val="000000"/>
                </a:solidFill>
                <a:latin typeface="Arial-BoldMT"/>
              </a:rPr>
              <a:t>In CFS (</a:t>
            </a:r>
            <a:r>
              <a:rPr lang="en-US" sz="1400" b="1" dirty="0">
                <a:solidFill>
                  <a:srgbClr val="000000"/>
                </a:solidFill>
                <a:latin typeface="Arial-BoldMT"/>
              </a:rPr>
              <a:t>A</a:t>
            </a:r>
            <a:r>
              <a:rPr lang="en-US" sz="1400" dirty="0">
                <a:solidFill>
                  <a:srgbClr val="000000"/>
                </a:solidFill>
                <a:latin typeface="Arial-BoldMT"/>
              </a:rPr>
              <a:t>) and EXO (</a:t>
            </a:r>
            <a:r>
              <a:rPr lang="en-US" sz="1400" b="1" dirty="0">
                <a:solidFill>
                  <a:srgbClr val="000000"/>
                </a:solidFill>
                <a:latin typeface="Arial-BoldMT"/>
              </a:rPr>
              <a:t>B</a:t>
            </a:r>
            <a:r>
              <a:rPr lang="en-US" sz="1400" dirty="0">
                <a:solidFill>
                  <a:srgbClr val="000000"/>
                </a:solidFill>
                <a:latin typeface="Arial-BoldMT"/>
              </a:rPr>
              <a:t>), the peaks corresponding to 18S and 28S ribosomal RNA are absent. In MV (</a:t>
            </a:r>
            <a:r>
              <a:rPr lang="en-US" sz="1400" b="1" dirty="0">
                <a:solidFill>
                  <a:srgbClr val="000000"/>
                </a:solidFill>
                <a:latin typeface="Arial-BoldMT"/>
              </a:rPr>
              <a:t>C</a:t>
            </a:r>
            <a:r>
              <a:rPr lang="en-US" sz="1400" dirty="0">
                <a:solidFill>
                  <a:srgbClr val="000000"/>
                </a:solidFill>
                <a:latin typeface="Arial-BoldMT"/>
              </a:rPr>
              <a:t>), minor peaks for 18S and 28S ribosomal RNAs can be observed. In EV-D (</a:t>
            </a:r>
            <a:r>
              <a:rPr lang="en-US" sz="1400" b="1" dirty="0">
                <a:solidFill>
                  <a:srgbClr val="000000"/>
                </a:solidFill>
                <a:latin typeface="Arial-BoldMT"/>
              </a:rPr>
              <a:t>D</a:t>
            </a:r>
            <a:r>
              <a:rPr lang="en-US" sz="1400" dirty="0">
                <a:solidFill>
                  <a:srgbClr val="000000"/>
                </a:solidFill>
                <a:latin typeface="Arial-BoldMT"/>
              </a:rPr>
              <a:t>), only the 18S ribosomal RNA is present.</a:t>
            </a:r>
            <a:r>
              <a:rPr lang="en-US" sz="1400" i="0" dirty="0">
                <a:solidFill>
                  <a:srgbClr val="000000"/>
                </a:solidFill>
                <a:effectLst/>
                <a:latin typeface="Arial-BoldMT"/>
              </a:rPr>
              <a:t> CFS, cell-free saliva; EXO, exosome; MV, </a:t>
            </a:r>
            <a:r>
              <a:rPr lang="en-US" sz="1400" i="0" dirty="0" err="1">
                <a:solidFill>
                  <a:srgbClr val="000000"/>
                </a:solidFill>
                <a:effectLst/>
                <a:latin typeface="Arial-BoldMT"/>
              </a:rPr>
              <a:t>microvesicle</a:t>
            </a:r>
            <a:r>
              <a:rPr lang="en-US" sz="1400" i="0" dirty="0">
                <a:solidFill>
                  <a:srgbClr val="000000"/>
                </a:solidFill>
                <a:effectLst/>
                <a:latin typeface="Arial-BoldMT"/>
              </a:rPr>
              <a:t>; EV-D, EV-depleted saliva.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4793917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</TotalTime>
  <Words>279</Words>
  <Application>Microsoft Office PowerPoint</Application>
  <PresentationFormat>Widescreen</PresentationFormat>
  <Paragraphs>23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-BoldMT</vt:lpstr>
      <vt:lpstr>ArialMT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童 方佳</dc:creator>
  <cp:lastModifiedBy>Tong, Fangjia</cp:lastModifiedBy>
  <cp:revision>25</cp:revision>
  <dcterms:created xsi:type="dcterms:W3CDTF">2023-01-09T21:49:05Z</dcterms:created>
  <dcterms:modified xsi:type="dcterms:W3CDTF">2023-06-08T21:55:47Z</dcterms:modified>
</cp:coreProperties>
</file>